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33.png" ContentType="image/png"/>
  <Override PartName="/ppt/media/image15.png" ContentType="image/png"/>
  <Override PartName="/ppt/media/image3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23.png" ContentType="image/png"/>
  <Override PartName="/ppt/media/image60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40.png" ContentType="image/png"/>
  <Override PartName="/ppt/media/image41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37.xml" ContentType="application/vnd.openxmlformats-officedocument.presentationml.slide+xml"/>
  <Override PartName="/ppt/slides/slide36.xml" ContentType="application/vnd.openxmlformats-officedocument.presentationml.slide+xml"/>
  <Override PartName="/ppt/slides/slide3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slide30.xml" ContentType="application/vnd.openxmlformats-officedocument.presentationml.slide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24.xml.rels" ContentType="application/vnd.openxmlformats-package.relationships+xml"/>
  <Override PartName="/ppt/slides/_rels/slide25.xml.rels" ContentType="application/vnd.openxmlformats-package.relationships+xml"/>
  <Override PartName="/ppt/slides/_rels/slide17.xml.rels" ContentType="application/vnd.openxmlformats-package.relationships+xml"/>
  <Override PartName="/ppt/slides/_rels/slide21.xml.rels" ContentType="application/vnd.openxmlformats-package.relationships+xml"/>
  <Override PartName="/ppt/slides/_rels/slide26.xml.rels" ContentType="application/vnd.openxmlformats-package.relationships+xml"/>
  <Override PartName="/ppt/slides/_rels/slide27.xml.rels" ContentType="application/vnd.openxmlformats-package.relationships+xml"/>
  <Override PartName="/ppt/slides/_rels/slide28.xml.rels" ContentType="application/vnd.openxmlformats-package.relationships+xml"/>
  <Override PartName="/ppt/slides/_rels/slide29.xml.rels" ContentType="application/vnd.openxmlformats-package.relationships+xml"/>
  <Override PartName="/ppt/slides/_rels/slide33.xml.rels" ContentType="application/vnd.openxmlformats-package.relationships+xml"/>
  <Override PartName="/ppt/slides/_rels/slide64.xml.rels" ContentType="application/vnd.openxmlformats-package.relationships+xml"/>
  <Override PartName="/ppt/slides/_rels/slide88.xml.rels" ContentType="application/vnd.openxmlformats-package.relationships+xml"/>
  <Override PartName="/ppt/slides/_rels/slide73.xml.rels" ContentType="application/vnd.openxmlformats-package.relationships+xml"/>
  <Override PartName="/ppt/slides/_rels/slide69.xml.rels" ContentType="application/vnd.openxmlformats-package.relationships+xml"/>
  <Override PartName="/ppt/slides/_rels/slide95.xml.rels" ContentType="application/vnd.openxmlformats-package.relationships+xml"/>
  <Override PartName="/ppt/slides/_rels/slide79.xml.rels" ContentType="application/vnd.openxmlformats-package.relationships+xml"/>
  <Override PartName="/ppt/slides/_rels/slide83.xml.rels" ContentType="application/vnd.openxmlformats-package.relationships+xml"/>
  <Override PartName="/ppt/slides/_rels/slide30.xml.rels" ContentType="application/vnd.openxmlformats-package.relationships+xml"/>
  <Override PartName="/ppt/slides/_rels/slide110.xml.rels" ContentType="application/vnd.openxmlformats-package.relationships+xml"/>
  <Override PartName="/ppt/slides/_rels/slide80.xml.rels" ContentType="application/vnd.openxmlformats-package.relationships+xml"/>
  <Override PartName="/ppt/slides/_rels/slide96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97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104.xml.rels" ContentType="application/vnd.openxmlformats-package.relationships+xml"/>
  <Override PartName="/ppt/slides/_rels/slide74.xml.rels" ContentType="application/vnd.openxmlformats-package.relationships+xml"/>
  <Override PartName="/ppt/slides/_rels/slide90.xml.rels" ContentType="application/vnd.openxmlformats-package.relationships+xml"/>
  <Override PartName="/ppt/slides/_rels/slide98.xml.rels" ContentType="application/vnd.openxmlformats-package.relationships+xml"/>
  <Override PartName="/ppt/slides/_rels/slide45.xml.rels" ContentType="application/vnd.openxmlformats-package.relationships+xml"/>
  <Override PartName="/ppt/slides/_rels/slide105.xml.rels" ContentType="application/vnd.openxmlformats-package.relationships+xml"/>
  <Override PartName="/ppt/slides/_rels/slide75.xml.rels" ContentType="application/vnd.openxmlformats-package.relationships+xml"/>
  <Override PartName="/ppt/slides/_rels/slide84.xml.rels" ContentType="application/vnd.openxmlformats-package.relationships+xml"/>
  <Override PartName="/ppt/slides/_rels/slide31.xml.rels" ContentType="application/vnd.openxmlformats-package.relationships+xml"/>
  <Override PartName="/ppt/slides/_rels/slide91.xml.rels" ContentType="application/vnd.openxmlformats-package.relationships+xml"/>
  <Override PartName="/ppt/slides/_rels/slide99.xml.rels" ContentType="application/vnd.openxmlformats-package.relationships+xml"/>
  <Override PartName="/ppt/slides/_rels/slide50.xml.rels" ContentType="application/vnd.openxmlformats-package.relationships+xml"/>
  <Override PartName="/ppt/slides/_rels/slide106.xml.rels" ContentType="application/vnd.openxmlformats-package.relationships+xml"/>
  <Override PartName="/ppt/slides/_rels/slide76.xml.rels" ContentType="application/vnd.openxmlformats-package.relationships+xml"/>
  <Override PartName="/ppt/slides/_rels/slide92.xml.rels" ContentType="application/vnd.openxmlformats-package.relationships+xml"/>
  <Override PartName="/ppt/slides/_rels/slide85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109.xml.rels" ContentType="application/vnd.openxmlformats-package.relationships+xml"/>
  <Override PartName="/ppt/slides/_rels/slide101.xml.rels" ContentType="application/vnd.openxmlformats-package.relationships+xml"/>
  <Override PartName="/ppt/slides/_rels/slide78.xml.rels" ContentType="application/vnd.openxmlformats-package.relationships+xml"/>
  <Override PartName="/ppt/slides/_rels/slide94.xml.rels" ContentType="application/vnd.openxmlformats-package.relationships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63.xml.rels" ContentType="application/vnd.openxmlformats-package.relationships+xml"/>
  <Override PartName="/ppt/slides/_rels/slide15.xml.rels" ContentType="application/vnd.openxmlformats-package.relationships+xml"/>
  <Override PartName="/ppt/slides/_rels/slide39.xml.rels" ContentType="application/vnd.openxmlformats-package.relationships+xml"/>
  <Override PartName="/ppt/slides/_rels/slide11.xml.rels" ContentType="application/vnd.openxmlformats-package.relationships+xml"/>
  <Override PartName="/ppt/slides/_rels/slide48.xml.rels" ContentType="application/vnd.openxmlformats-package.relationships+xml"/>
  <Override PartName="/ppt/slides/_rels/slide55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81.xml.rels" ContentType="application/vnd.openxmlformats-package.relationships+xml"/>
  <Override PartName="/ppt/slides/_rels/slide65.xml.rels" ContentType="application/vnd.openxmlformats-package.relationships+xml"/>
  <Override PartName="/ppt/slides/_rels/slide103.xml.rels" ContentType="application/vnd.openxmlformats-package.relationships+xml"/>
  <Override PartName="/ppt/slides/_rels/slide58.xml.rels" ContentType="application/vnd.openxmlformats-package.relationships+xml"/>
  <Override PartName="/ppt/slides/_rels/slide12.xml.rels" ContentType="application/vnd.openxmlformats-package.relationships+xml"/>
  <Override PartName="/ppt/slides/_rels/slide102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62.xml.rels" ContentType="application/vnd.openxmlformats-package.relationships+xml"/>
  <Override PartName="/ppt/slides/_rels/slide72.xml.rels" ContentType="application/vnd.openxmlformats-package.relationships+xml"/>
  <Override PartName="/ppt/slides/_rels/slide68.xml.rels" ContentType="application/vnd.openxmlformats-package.relationships+xml"/>
  <Override PartName="/ppt/slides/_rels/slide52.xml.rels" ContentType="application/vnd.openxmlformats-package.relationships+xml"/>
  <Override PartName="/ppt/slides/_rels/slide13.xml.rels" ContentType="application/vnd.openxmlformats-package.relationships+xml"/>
  <Override PartName="/ppt/slides/_rels/slide38.xml.rels" ContentType="application/vnd.openxmlformats-package.relationships+xml"/>
  <Override PartName="/ppt/slides/_rels/slide89.xml.rels" ContentType="application/vnd.openxmlformats-package.relationships+xml"/>
  <Override PartName="/ppt/slides/_rels/slide14.xml.rels" ContentType="application/vnd.openxmlformats-package.relationships+xml"/>
  <Override PartName="/ppt/slides/_rels/slide37.xml.rels" ContentType="application/vnd.openxmlformats-package.relationships+xml"/>
  <Override PartName="/ppt/slides/_rels/slide87.xml.rels" ContentType="application/vnd.openxmlformats-package.relationships+xml"/>
  <Override PartName="/ppt/slides/_rels/slide3.xml.rels" ContentType="application/vnd.openxmlformats-package.relationships+xml"/>
  <Override PartName="/ppt/slides/_rels/slide36.xml.rels" ContentType="application/vnd.openxmlformats-package.relationships+xml"/>
  <Override PartName="/ppt/slides/_rels/slide108.xml.rels" ContentType="application/vnd.openxmlformats-package.relationships+xml"/>
  <Override PartName="/ppt/slides/_rels/slide70.xml.rels" ContentType="application/vnd.openxmlformats-package.relationships+xml"/>
  <Override PartName="/ppt/slides/_rels/slide100.xml.rels" ContentType="application/vnd.openxmlformats-package.relationships+xml"/>
  <Override PartName="/ppt/slides/_rels/slide77.xml.rels" ContentType="application/vnd.openxmlformats-package.relationships+xml"/>
  <Override PartName="/ppt/slides/_rels/slide67.xml.rels" ContentType="application/vnd.openxmlformats-package.relationships+xml"/>
  <Override PartName="/ppt/slides/_rels/slide71.xml.rels" ContentType="application/vnd.openxmlformats-package.relationships+xml"/>
  <Override PartName="/ppt/slides/_rels/slide2.xml.rels" ContentType="application/vnd.openxmlformats-package.relationships+xml"/>
  <Override PartName="/ppt/slides/_rels/slide86.xml.rels" ContentType="application/vnd.openxmlformats-package.relationships+xml"/>
  <Override PartName="/ppt/slides/_rels/slide93.xml.rels" ContentType="application/vnd.openxmlformats-package.relationships+xml"/>
  <Override PartName="/ppt/slides/_rels/slide107.xml.rels" ContentType="application/vnd.openxmlformats-package.relationships+xml"/>
  <Override PartName="/ppt/slides/_rels/slide66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82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6.xml" ContentType="application/vnd.openxmlformats-officedocument.presentationml.slide+xml"/>
  <Override PartName="/ppt/slides/slide49.xml" ContentType="application/vnd.openxmlformats-officedocument.presentationml.slide+xml"/>
  <Override PartName="/ppt/slides/slide102.xml" ContentType="application/vnd.openxmlformats-officedocument.presentationml.slide+xml"/>
  <Override PartName="/ppt/slides/slide12.xml" ContentType="application/vnd.openxmlformats-officedocument.presentationml.slide+xml"/>
  <Override PartName="/ppt/slides/slide5.xml" ContentType="application/vnd.openxmlformats-officedocument.presentationml.slide+xml"/>
  <Override PartName="/ppt/slides/slide44.xml" ContentType="application/vnd.openxmlformats-officedocument.presentationml.slide+xml"/>
  <Override PartName="/ppt/slides/slide9.xml" ContentType="application/vnd.openxmlformats-officedocument.presentationml.slide+xml"/>
  <Override PartName="/ppt/slides/slide16.xml" ContentType="application/vnd.openxmlformats-officedocument.presentationml.slide+xml"/>
  <Override PartName="/ppt/slides/slide81.xml" ContentType="application/vnd.openxmlformats-officedocument.presentationml.slide+xml"/>
  <Override PartName="/ppt/slides/slide48.xml" ContentType="application/vnd.openxmlformats-officedocument.presentationml.slide+xml"/>
  <Override PartName="/ppt/slides/slide101.xml" ContentType="application/vnd.openxmlformats-officedocument.presentationml.slide+xml"/>
  <Override PartName="/ppt/slides/slide11.xml" ContentType="application/vnd.openxmlformats-officedocument.presentationml.slide+xml"/>
  <Override PartName="/ppt/slides/slide4.xml" ContentType="application/vnd.openxmlformats-officedocument.presentationml.slide+xml"/>
  <Override PartName="/ppt/slides/slide43.xml" ContentType="application/vnd.openxmlformats-officedocument.presentationml.slide+xml"/>
  <Override PartName="/ppt/slides/slide8.xml" ContentType="application/vnd.openxmlformats-officedocument.presentationml.slide+xml"/>
  <Override PartName="/ppt/slides/slide15.xml" ContentType="application/vnd.openxmlformats-officedocument.presentationml.slide+xml"/>
  <Override PartName="/ppt/slides/slide80.xml" ContentType="application/vnd.openxmlformats-officedocument.presentationml.slide+xml"/>
  <Override PartName="/ppt/slides/slide47.xml" ContentType="application/vnd.openxmlformats-officedocument.presentationml.slide+xml"/>
  <Override PartName="/ppt/slides/slide100.xml" ContentType="application/vnd.openxmlformats-officedocument.presentationml.slide+xml"/>
  <Override PartName="/ppt/slides/slide10.xml" ContentType="application/vnd.openxmlformats-officedocument.presentationml.slide+xml"/>
  <Override PartName="/ppt/slides/slide3.xml" ContentType="application/vnd.openxmlformats-officedocument.presentationml.slide+xml"/>
  <Override PartName="/ppt/slides/slide109.xml" ContentType="application/vnd.openxmlformats-officedocument.presentationml.slide+xml"/>
  <Override PartName="/ppt/slides/slide42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41.xml" ContentType="application/vnd.openxmlformats-officedocument.presentationml.slide+xml"/>
  <Override PartName="/ppt/slides/slide40.xml" ContentType="application/vnd.openxmlformats-officedocument.presentationml.slide+xml"/>
  <Override PartName="/ppt/slides/slide2.xml" ContentType="application/vnd.openxmlformats-officedocument.presentationml.slide+xml"/>
  <Override PartName="/ppt/slides/slide108.xml" ContentType="application/vnd.openxmlformats-officedocument.presentationml.slide+xml"/>
  <Override PartName="/ppt/slides/slide1.xml" ContentType="application/vnd.openxmlformats-officedocument.presentationml.slide+xml"/>
  <Override PartName="/ppt/slides/slide107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70.xml" ContentType="application/vnd.openxmlformats-officedocument.presentationml.slide+xml"/>
  <Override PartName="/ppt/slides/slide69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85.xml" ContentType="application/vnd.openxmlformats-officedocument.presentationml.slide+xml"/>
  <Override PartName="/ppt/slides/slide106.xml" ContentType="application/vnd.openxmlformats-officedocument.presentationml.slide+xml"/>
  <Override PartName="/ppt/slides/slide98.xml" ContentType="application/vnd.openxmlformats-officedocument.presentationml.slide+xml"/>
  <Override PartName="/ppt/slides/slide61.xml" ContentType="application/vnd.openxmlformats-officedocument.presentationml.slide+xml"/>
  <Override PartName="/ppt/slides/slide89.xml" ContentType="application/vnd.openxmlformats-officedocument.presentationml.slide+xml"/>
  <Override PartName="/ppt/slides/slide105.xml" ContentType="application/vnd.openxmlformats-officedocument.presentationml.slide+xml"/>
  <Override PartName="/ppt/slides/slide97.xml" ContentType="application/vnd.openxmlformats-officedocument.presentationml.slide+xml"/>
  <Override PartName="/ppt/slides/slide60.xml" ContentType="application/vnd.openxmlformats-officedocument.presentationml.slide+xml"/>
  <Override PartName="/ppt/slides/slide88.xml" ContentType="application/vnd.openxmlformats-officedocument.presentationml.slide+xml"/>
  <Override PartName="/ppt/slides/slide79.xml" ContentType="application/vnd.openxmlformats-officedocument.presentationml.slide+xml"/>
  <Override PartName="/ppt/slides/slide104.xml" ContentType="application/vnd.openxmlformats-officedocument.presentationml.slide+xml"/>
  <Override PartName="/ppt/slides/slide96.xml" ContentType="application/vnd.openxmlformats-officedocument.presentationml.slide+xml"/>
  <Override PartName="/ppt/slides/slide99.xml" ContentType="application/vnd.openxmlformats-officedocument.presentationml.slide+xml"/>
  <Override PartName="/ppt/slides/slide62.xml" ContentType="application/vnd.openxmlformats-officedocument.presentationml.slide+xml"/>
  <Override PartName="/ppt/slides/slide87.xml" ContentType="application/vnd.openxmlformats-officedocument.presentationml.slide+xml"/>
  <Override PartName="/ppt/slides/slide78.xml" ContentType="application/vnd.openxmlformats-officedocument.presentationml.slide+xml"/>
  <Override PartName="/ppt/slides/slide103.xml" ContentType="application/vnd.openxmlformats-officedocument.presentationml.slide+xml"/>
  <Override PartName="/ppt/slides/slide95.xml" ContentType="application/vnd.openxmlformats-officedocument.presentationml.slide+xml"/>
  <Override PartName="/ppt/slides/slide86.xml" ContentType="application/vnd.openxmlformats-officedocument.presentationml.slide+xml"/>
  <Override PartName="/ppt/slides/slide64.xml" ContentType="application/vnd.openxmlformats-officedocument.presentationml.slide+xml"/>
  <Override PartName="/ppt/slides/slide63.xml" ContentType="application/vnd.openxmlformats-officedocument.presentationml.slide+xml"/>
  <Override PartName="/ppt/slides/slide29.xml" ContentType="application/vnd.openxmlformats-officedocument.presentationml.slide+xml"/>
  <Override PartName="/ppt/slides/slide94.xml" ContentType="application/vnd.openxmlformats-officedocument.presentationml.slide+xml"/>
  <Override PartName="/ppt/slides/slide28.xml" ContentType="application/vnd.openxmlformats-officedocument.presentationml.slide+xml"/>
  <Override PartName="/ppt/slides/slide93.xml" ContentType="application/vnd.openxmlformats-officedocument.presentationml.slide+xml"/>
  <Override PartName="/ppt/slides/slide92.xml" ContentType="application/vnd.openxmlformats-officedocument.presentationml.slide+xml"/>
  <Override PartName="/ppt/slides/slide27.xml" ContentType="application/vnd.openxmlformats-officedocument.presentationml.slide+xml"/>
  <Override PartName="/ppt/slides/slide91.xml" ContentType="application/vnd.openxmlformats-officedocument.presentationml.slide+xml"/>
  <Override PartName="/ppt/slides/slide26.xml" ContentType="application/vnd.openxmlformats-officedocument.presentationml.slide+xml"/>
  <Override PartName="/ppt/slides/slide90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19.xml" ContentType="application/vnd.openxmlformats-officedocument.presentationml.slide+xml"/>
  <Override PartName="/ppt/slides/slide84.xml" ContentType="application/vnd.openxmlformats-officedocument.presentationml.slide+xml"/>
  <Override PartName="/ppt/slides/slide20.xml" ContentType="application/vnd.openxmlformats-officedocument.presentationml.slide+xml"/>
  <Override PartName="/ppt/slides/slide110.xml" ContentType="application/vnd.openxmlformats-officedocument.presentationml.slide+xml"/>
  <Override PartName="/ppt/slides/slide57.xml" ContentType="application/vnd.openxmlformats-officedocument.presentationml.slide+xml"/>
  <Override PartName="/ppt/slides/slide18.xml" ContentType="application/vnd.openxmlformats-officedocument.presentationml.slide+xml"/>
  <Override PartName="/ppt/slides/slide83.xml" ContentType="application/vnd.openxmlformats-officedocument.presentationml.slide+xml"/>
  <Override PartName="/ppt/slides/slide17.xml" ContentType="application/vnd.openxmlformats-officedocument.presentationml.slide+xml"/>
  <Override PartName="/ppt/slides/slide8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  <p:sldId id="329" r:id="rId76"/>
    <p:sldId id="330" r:id="rId77"/>
    <p:sldId id="331" r:id="rId78"/>
    <p:sldId id="332" r:id="rId79"/>
    <p:sldId id="333" r:id="rId80"/>
    <p:sldId id="334" r:id="rId81"/>
    <p:sldId id="335" r:id="rId82"/>
    <p:sldId id="336" r:id="rId83"/>
    <p:sldId id="337" r:id="rId84"/>
    <p:sldId id="338" r:id="rId85"/>
    <p:sldId id="339" r:id="rId86"/>
    <p:sldId id="340" r:id="rId87"/>
    <p:sldId id="341" r:id="rId88"/>
    <p:sldId id="342" r:id="rId89"/>
    <p:sldId id="343" r:id="rId90"/>
    <p:sldId id="344" r:id="rId91"/>
    <p:sldId id="345" r:id="rId92"/>
    <p:sldId id="346" r:id="rId93"/>
    <p:sldId id="347" r:id="rId94"/>
    <p:sldId id="348" r:id="rId95"/>
    <p:sldId id="349" r:id="rId96"/>
    <p:sldId id="350" r:id="rId97"/>
    <p:sldId id="351" r:id="rId98"/>
    <p:sldId id="352" r:id="rId99"/>
    <p:sldId id="353" r:id="rId100"/>
    <p:sldId id="354" r:id="rId101"/>
    <p:sldId id="355" r:id="rId102"/>
    <p:sldId id="356" r:id="rId103"/>
    <p:sldId id="357" r:id="rId104"/>
    <p:sldId id="358" r:id="rId105"/>
    <p:sldId id="359" r:id="rId106"/>
    <p:sldId id="360" r:id="rId107"/>
    <p:sldId id="361" r:id="rId108"/>
    <p:sldId id="362" r:id="rId109"/>
    <p:sldId id="363" r:id="rId110"/>
    <p:sldId id="364" r:id="rId111"/>
    <p:sldId id="365" r:id="rId1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slide" Target="slides/slide71.xml"/><Relationship Id="rId74" Type="http://schemas.openxmlformats.org/officeDocument/2006/relationships/slide" Target="slides/slide72.xml"/><Relationship Id="rId75" Type="http://schemas.openxmlformats.org/officeDocument/2006/relationships/slide" Target="slides/slide73.xml"/><Relationship Id="rId76" Type="http://schemas.openxmlformats.org/officeDocument/2006/relationships/slide" Target="slides/slide74.xml"/><Relationship Id="rId77" Type="http://schemas.openxmlformats.org/officeDocument/2006/relationships/slide" Target="slides/slide75.xml"/><Relationship Id="rId78" Type="http://schemas.openxmlformats.org/officeDocument/2006/relationships/slide" Target="slides/slide76.xml"/><Relationship Id="rId79" Type="http://schemas.openxmlformats.org/officeDocument/2006/relationships/slide" Target="slides/slide77.xml"/><Relationship Id="rId80" Type="http://schemas.openxmlformats.org/officeDocument/2006/relationships/slide" Target="slides/slide78.xml"/><Relationship Id="rId81" Type="http://schemas.openxmlformats.org/officeDocument/2006/relationships/slide" Target="slides/slide79.xml"/><Relationship Id="rId82" Type="http://schemas.openxmlformats.org/officeDocument/2006/relationships/slide" Target="slides/slide80.xml"/><Relationship Id="rId83" Type="http://schemas.openxmlformats.org/officeDocument/2006/relationships/slide" Target="slides/slide81.xml"/><Relationship Id="rId84" Type="http://schemas.openxmlformats.org/officeDocument/2006/relationships/slide" Target="slides/slide82.xml"/><Relationship Id="rId85" Type="http://schemas.openxmlformats.org/officeDocument/2006/relationships/slide" Target="slides/slide83.xml"/><Relationship Id="rId86" Type="http://schemas.openxmlformats.org/officeDocument/2006/relationships/slide" Target="slides/slide84.xml"/><Relationship Id="rId87" Type="http://schemas.openxmlformats.org/officeDocument/2006/relationships/slide" Target="slides/slide85.xml"/><Relationship Id="rId88" Type="http://schemas.openxmlformats.org/officeDocument/2006/relationships/slide" Target="slides/slide86.xml"/><Relationship Id="rId89" Type="http://schemas.openxmlformats.org/officeDocument/2006/relationships/slide" Target="slides/slide87.xml"/><Relationship Id="rId90" Type="http://schemas.openxmlformats.org/officeDocument/2006/relationships/slide" Target="slides/slide88.xml"/><Relationship Id="rId91" Type="http://schemas.openxmlformats.org/officeDocument/2006/relationships/slide" Target="slides/slide89.xml"/><Relationship Id="rId92" Type="http://schemas.openxmlformats.org/officeDocument/2006/relationships/slide" Target="slides/slide90.xml"/><Relationship Id="rId93" Type="http://schemas.openxmlformats.org/officeDocument/2006/relationships/slide" Target="slides/slide91.xml"/><Relationship Id="rId94" Type="http://schemas.openxmlformats.org/officeDocument/2006/relationships/slide" Target="slides/slide92.xml"/><Relationship Id="rId95" Type="http://schemas.openxmlformats.org/officeDocument/2006/relationships/slide" Target="slides/slide93.xml"/><Relationship Id="rId96" Type="http://schemas.openxmlformats.org/officeDocument/2006/relationships/slide" Target="slides/slide94.xml"/><Relationship Id="rId97" Type="http://schemas.openxmlformats.org/officeDocument/2006/relationships/slide" Target="slides/slide95.xml"/><Relationship Id="rId98" Type="http://schemas.openxmlformats.org/officeDocument/2006/relationships/slide" Target="slides/slide96.xml"/><Relationship Id="rId99" Type="http://schemas.openxmlformats.org/officeDocument/2006/relationships/slide" Target="slides/slide97.xml"/><Relationship Id="rId100" Type="http://schemas.openxmlformats.org/officeDocument/2006/relationships/slide" Target="slides/slide98.xml"/><Relationship Id="rId101" Type="http://schemas.openxmlformats.org/officeDocument/2006/relationships/slide" Target="slides/slide99.xml"/><Relationship Id="rId102" Type="http://schemas.openxmlformats.org/officeDocument/2006/relationships/slide" Target="slides/slide100.xml"/><Relationship Id="rId103" Type="http://schemas.openxmlformats.org/officeDocument/2006/relationships/slide" Target="slides/slide101.xml"/><Relationship Id="rId104" Type="http://schemas.openxmlformats.org/officeDocument/2006/relationships/slide" Target="slides/slide102.xml"/><Relationship Id="rId105" Type="http://schemas.openxmlformats.org/officeDocument/2006/relationships/slide" Target="slides/slide103.xml"/><Relationship Id="rId106" Type="http://schemas.openxmlformats.org/officeDocument/2006/relationships/slide" Target="slides/slide104.xml"/><Relationship Id="rId107" Type="http://schemas.openxmlformats.org/officeDocument/2006/relationships/slide" Target="slides/slide105.xml"/><Relationship Id="rId108" Type="http://schemas.openxmlformats.org/officeDocument/2006/relationships/slide" Target="slides/slide106.xml"/><Relationship Id="rId109" Type="http://schemas.openxmlformats.org/officeDocument/2006/relationships/slide" Target="slides/slide107.xml"/><Relationship Id="rId110" Type="http://schemas.openxmlformats.org/officeDocument/2006/relationships/slide" Target="slides/slide108.xml"/><Relationship Id="rId111" Type="http://schemas.openxmlformats.org/officeDocument/2006/relationships/slide" Target="slides/slide109.xml"/><Relationship Id="rId112" Type="http://schemas.openxmlformats.org/officeDocument/2006/relationships/slide" Target="slides/slide110.xml"/><Relationship Id="rId1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BF588-F261-4893-BF7E-B2422958B3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857BE-D18A-45DE-9971-D9848FDD12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11CF6-5C81-4897-BBF5-9A8AF80A76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8494A-79FC-4FE6-BFF0-00BC1C5780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1EF2E-C043-43DC-8FBE-7D0CB0CAA4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F2953-1DB5-4A20-ABAA-F6415C5D15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36C8B-30A8-45F7-92A6-175E1EE38B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E61BF-32C7-41F3-8A0A-EA3DCC9726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237F6-354C-4E46-92F8-BA5C56AF04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E4E73-F025-4C20-A49E-6BB4639A5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A8A32-DA3C-4A6D-AFCF-6AB9A6977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B6B71-6AE7-4F46-AEF6-449F2B2C8F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29ECC5-E97B-4E26-9985-ADA23F4A37F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2.xml"/>
</Relationships>
</file>

<file path=ppt/slides/_rels/slide100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slideLayout" Target="../slideLayouts/slideLayout2.xml"/>
</Relationships>
</file>

<file path=ppt/slides/_rels/slide10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3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slideLayout" Target="../slideLayouts/slideLayout2.xml"/>
</Relationships>
</file>

<file path=ppt/slides/_rels/slide104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slideLayout" Target="../slideLayouts/slideLayout2.xml"/>
</Relationships>
</file>

<file path=ppt/slides/_rels/slide105.xml.rels><?xml version="1.0" encoding="UTF-8"?>
<Relationships xmlns="http://schemas.openxmlformats.org/package/2006/relationships"><Relationship Id="rId1" Type="http://schemas.openxmlformats.org/officeDocument/2006/relationships/image" Target="../media/image68.png"/><Relationship Id="rId2" Type="http://schemas.openxmlformats.org/officeDocument/2006/relationships/slideLayout" Target="../slideLayouts/slideLayout2.xml"/>
</Relationships>
</file>

<file path=ppt/slides/_rels/slide106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slideLayout" Target="../slideLayouts/slideLayout2.xml"/>
</Relationships>
</file>

<file path=ppt/slides/_rels/slide10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9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slideLayout" Target="../slideLayouts/slideLayout2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.xml"/>
</Relationships>
</file>

<file path=ppt/slides/_rels/slide110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slideLayout" Target="../slideLayouts/slideLayout2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2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2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2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2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2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2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2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2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2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2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2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3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2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2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3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2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2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2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2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2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2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2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2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2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2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2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2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2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2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2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2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2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2.xml"/>
</Relationships>
</file>

<file path=ppt/slides/_rels/slide7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3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2.xml"/>
</Relationships>
</file>

<file path=ppt/slides/_rels/slide74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2.xml"/>
</Relationships>
</file>

<file path=ppt/slides/_rels/slide75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2.xml"/>
</Relationships>
</file>

<file path=ppt/slides/_rels/slide7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8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2.xml"/>
</Relationships>
</file>

<file path=ppt/slides/_rels/slide79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0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slideLayout" Target="../slideLayouts/slideLayout2.xml"/>
</Relationships>
</file>

<file path=ppt/slides/_rels/slide8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3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slideLayout" Target="../slideLayouts/slideLayout2.xml"/>
</Relationships>
</file>

<file path=ppt/slides/_rels/slide84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slideLayout" Target="../slideLayouts/slideLayout2.xml"/>
</Relationships>
</file>

<file path=ppt/slides/_rels/slide85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2.xml"/>
</Relationships>
</file>

<file path=ppt/slides/_rels/slide8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7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slideLayout" Target="../slideLayouts/slideLayout3.xml"/>
</Relationships>
</file>

<file path=ppt/slides/_rels/slide88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slideLayout" Target="../slideLayouts/slideLayout2.xml"/>
</Relationships>
</file>

<file path=ppt/slides/_rels/slide89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2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slideLayout" Target="../slideLayouts/slideLayout2.xml"/>
</Relationships>
</file>

<file path=ppt/slides/_rels/slide91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slideLayout" Target="../slideLayouts/slideLayout2.xml"/>
</Relationships>
</file>

<file path=ppt/slides/_rels/slide92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slideLayout" Target="../slideLayouts/slideLayout2.xml"/>
</Relationships>
</file>

<file path=ppt/slides/_rels/slide9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4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slideLayout" Target="../slideLayouts/slideLayout3.xml"/>
</Relationships>
</file>

<file path=ppt/slides/_rels/slide95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slideLayout" Target="../slideLayouts/slideLayout2.xml"/>
</Relationships>
</file>

<file path=ppt/slides/_rels/slide96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slideLayout" Target="../slideLayouts/slideLayout2.xml"/>
</Relationships>
</file>

<file path=ppt/slides/_rels/slide9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9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68360" y="11966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4000" spc="-1" strike="noStrike">
                <a:solidFill>
                  <a:srgbClr val="000000"/>
                </a:solidFill>
                <a:latin typeface="Arial"/>
              </a:rPr>
              <a:t>Supplemental_spectra_MS/MS</a:t>
            </a:r>
            <a:r>
              <a:rPr b="0" lang="zh-CN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24000" y="2924280"/>
            <a:ext cx="9144000" cy="374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Annotated spectra of 21 differentially expressed protein spots identified by MS/M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800" spc="-1" strike="noStrike">
                <a:solidFill>
                  <a:srgbClr val="000000"/>
                </a:solidFill>
                <a:latin typeface="Arial"/>
              </a:rPr>
              <a:t>CID: collision induced desorptio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9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VPSGASTGVYEALEL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C491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791.07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"/>
          <p:cNvSpPr/>
          <p:nvPr/>
        </p:nvSpPr>
        <p:spPr>
          <a:xfrm>
            <a:off x="611280" y="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229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86/5.11  Mr obsd/calcd:56417/5219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9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7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04920" y="2188440"/>
            <a:ext cx="8610480" cy="255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MAAAAAAAPP FAAGDSPPPT ALLLPRTTTT TAGAAPAPRR SSASSRLH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TAALAVATS YLLLILPRTP LSAAPAPAAA ARAQV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EK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VILISSDG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FGYQHKAA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PHIH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GNG TSAATGLVPI FPTLTFPNHY SIATGLYP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GIINNYFPD PISGDYFTMS SHEPKWWLGE PLWVTAADQG IQAATYFWP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EVKKGSWDC PDKYCRHYNG SVPFEERVDA ILGYFDLPSD EMPQFLTLY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EDPDHQGHQV GPDDPAITEA V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DEMIGR LIAGLEE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V FEDVNVILV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HGMVGTCDK KLVFLDELAP WIKLEEDWVL SMTPLLAIRP PDDMSLPDV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KMNEGLGSG 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ENGEY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 YLKEDLPS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YADSYRIPP IIGLPEEGY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EMKRSDKNE CGGAHGYDNA FFSM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IFI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G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EGGRV VPSFENVEI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VIASILNLE PAPNNGSSSF PDTILLPS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0" y="1599840"/>
            <a:ext cx="9144000" cy="342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Observed   Mr(expt)     Mr(calc)   Delta   Miss               Sequ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400" spc="-1" strike="noStrike">
                <a:solidFill>
                  <a:srgbClr val="000000"/>
                </a:solidFill>
                <a:latin typeface="Arial"/>
              </a:rPr>
              <a:t>          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7 - 101      1673.0963     1672.0890     1671.9559 0.1331    0            K.LEKPVVILISSDGF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7 - 101      1673.0963     1672.0890     1671.9559 0.1331    0            K.LEKPVVILISSDGF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2 - 107       779.4363       778.4290      778.3762   0.0528    0                        R.FGYQHK.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8 - 115       902.5741       901.5668      901.4882   0.0786    0                        K.AATPHIHR.L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4 - 280       833.4845       832.4772      832.4113   0.0660    0                        R.IDEMIG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81 - 288       900.5949       899.5876      899.5076   0.0800    0                        R.LIAGLEER.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62 - 369       979.5684       978.5611      978.4770   0.0841    0                        K.VENGEYLR.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80 - 387      1024.5699     1023.5626    1023.4774  0.0853    0                        R.LHYADSYR.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80 - 387      1024.5699     1023.5626    1023.4774  0.0853    0                        R.LHYADSYR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88 - 400      1425.8992     1424.8919    1424.7915  0.1005    0            R.IPPIIGLPEEGYK.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26 - 434      1011.6575     1010.6502    1010.5661  0.0841    0                        R.TIFIAHGP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26 - 434      1011.6575     1010.6502    1010.5661  0.0841    0                        R.TIFIAHGP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2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EKPVVILISSDGF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22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1673.09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8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2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HYADSY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22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1024.57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1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474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2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TIFIAHGP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22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1011.66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4" name="" descr=""/>
          <p:cNvPicPr/>
          <p:nvPr/>
        </p:nvPicPr>
        <p:blipFill>
          <a:blip r:embed="rId1"/>
          <a:stretch/>
        </p:blipFill>
        <p:spPr>
          <a:xfrm>
            <a:off x="380880" y="1371600"/>
            <a:ext cx="8291520" cy="474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795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9/5.55   Mr obsd/calcd:43003/47852 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7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9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304920" y="2352600"/>
            <a:ext cx="8610480" cy="280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VSPLLLL LLCSYHSVVA HAGDGQSYKV LELNSEAVCS ERNAISSSL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GTTVALNHRH GPCSPVPSSK 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PTEEELL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QLRAEHIQ RKFAMNAAV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AGDLQQSKV SSSVPTKLGS SLDTLEYVIS VGLGTPAVTQ TVTIDTGSD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WVQCNPCPN PPCYAQTGAL FDPAKSSTYR AVSCAAAECA QLEQQGNGC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TNYECQYGV QYGDGSTTNG TYSRDTLTLS GASDAVKGFQ FGCSHVESG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DQTDGLMGL GGGAQSLVSQ TAAAYGNSFS YCLPPTSGSS GFLTLGGGG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SGFVTTRML 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RQIPTFYG ARLQDIAVG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LGLSPSVF AAGSVVDSG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IIT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PPTA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ALSSAF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G MKQYRSAPAR SILDTCFDFA GQTQISIPT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LVFSGGAAI DLDPNGIMYG NCLAFAATGD DGTTGIIGNV QQRTFEVLY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GSSTLGFRS GA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-360" y="1447560"/>
            <a:ext cx="9372600" cy="297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1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– End   Observed   Mr(expt)    Mr(calc)    Delta    Miss        Sequence</a:t>
            </a:r>
            <a:r>
              <a:rPr b="1" lang="zh-CN" sz="4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72 - 80       1114.5985    1113.5912    1113.6030   -0.0117     0             K.RPTEEELLK.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2 - 322     1295.8142    1294.8069    1294.6782    0.1287     1            R.SRQIPTFYGA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4 - 322     1052.6572    1051.6499    1051.5450    0.1049     0            R.QIPTFYG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4 - 322     1052.6572    1051.6499    1051.5450    0.1049     0            R.QIPTFYG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23 - 331      900.5903      899.5830      899.5076     0.0754     0            R.LQDIAVGGK.Q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55 - 368     1452.9064    1451.8991    1451.7660    0.1331     0            R.LPPTAYSALSSAFK.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55 - 368     1452.9064    1451.8991    1451.7660    0.1331     0            R.LPPTAYSALSSAFK.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3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QIPTFYGA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795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52.66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6" name="" descr=""/>
          <p:cNvPicPr/>
          <p:nvPr/>
        </p:nvPicPr>
        <p:blipFill>
          <a:blip r:embed="rId1"/>
          <a:stretch/>
        </p:blipFill>
        <p:spPr>
          <a:xfrm>
            <a:off x="380880" y="13716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9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RAPVEPY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C491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78.57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3059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3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PPTAYSALSSAF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795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7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452.91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9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"/>
          <p:cNvSpPr/>
          <p:nvPr/>
        </p:nvSpPr>
        <p:spPr>
          <a:xfrm>
            <a:off x="684360" y="109440"/>
            <a:ext cx="7164360" cy="13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Arial"/>
              </a:rPr>
              <a:t>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3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67/5.93     Mr obsd/calcd:43648/4704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772400" y="304920"/>
            <a:ext cx="16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-360" y="46479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7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609480" y="144792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24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EAPRLRLPF LLLVALVVSP PAVAAAASRM RIEPLPTAAL RRLYDTSNY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LQLNNGLAL TPQMGWNSWN FFACNINETV IRDTADALVS TGLADLGYN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NIDDCWSNV KRGKKDQLLP DPKTFPSGIK DLADYVHGKG LKLGIYSDA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IFTCQVRPGS LHHE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DAAI FASWGVDYL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DNCYNLGIK P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RYPP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LNSTGRQIF YSLCEWGQDD PALWAG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G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W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TDDIQD TWKSMTDIA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NNKWASYAG PGGWNDPDML EVGNGGMTFA EYRAHFSIWA LMKAPLLIG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VRNMTKETM EILSN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VI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NQDPLGVQ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RILGQ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G CQEVWAGPL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N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AVVLW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EESANIIV 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PSVGLDG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PYS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LWK HETLSENVV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FGAQVDVHD CKMYIFTPAV TVA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0" y="1599840"/>
            <a:ext cx="9144000" cy="304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5000"/>
          </a:bodyPr>
          <a:p>
            <a:pPr marL="32580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Observed    Mr(expt)   Mr(calc)    Delta    Miss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6 - 180     1670.9453       1669.9380   1669.7987   0.1393     0         K.DDAAIFASWGVDYLK.Y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93 - 199      934.5092         933.5019     933.4491    0.0529     1         K.DRYPPMR.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93 - 199      950.4975         949.4902     949.4440    0.0463     1         K.DRYPPMR.D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Oxidation (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28 - 233      718.4064         717.3991     717.3558    0.0433     0         K.VGNSWR.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7 - 331     1651.9860       1650.9787   1650.8689   0.1099     0      K.EVIQVNQDPLGVQGR.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7 - 331     1651.9860       1650.9787   1650.8689   0.1099     0      K.EVIQVNQDPLGVQGR.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32 - 338      771.4922         770.4849     770.4762    0.0087     1          R.RILGQGK.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54 - 361      970.6488         969.6415     969.5759    0.0656     0          R.LAVVLWNR.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54 - 361      970.6488         969.6415     969.5759    0.0656     0          R.LAVVLWNR.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72 - 386     1533.8926       1532.8853   1532.7834   0.1019     0      K.LPSVGLDGSSPYSVR.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2580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72 - 386     1533.8926       1532.8853   1532.7834   0.1019     0      K.LPSVGLDGSSPYSVR.D           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4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VIQVNQDPLGVQ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651.9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380880" y="13716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4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AVVLWN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970.6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3049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4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PSVGLDGSSPYSV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533.8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8/7.02  Mr obsd/calcd:35187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7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04920" y="2837880"/>
            <a:ext cx="8610480" cy="182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KMGFAPMLSV AVLLGTLAAF PAAVHSIGVC YGVVANNLPG PSEVVQLY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NIQAYPGV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IAVGNEV QGSDTANILP AMRNVNSALV AAGLGNIK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DA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FPPSSGRFR DDYMTPIARF LATTGAPL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NVYPYFAY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QESGQKNIM LNYATFQPGT TVVDNGNRLT YTCLFDAMVD SIYAALEKA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PSVSVVVSE SGWPSAGG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ASVNNAQTY 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 FGLFNPNKSP SYSISF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"/>
          <p:cNvSpPr/>
          <p:nvPr/>
        </p:nvSpPr>
        <p:spPr>
          <a:xfrm>
            <a:off x="684360" y="109440"/>
            <a:ext cx="60973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Q429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65/5.41  Mr obsd/calcd:62474/4797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0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-360" y="1447560"/>
            <a:ext cx="9372600" cy="335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000000"/>
                </a:solidFill>
                <a:latin typeface="Arial"/>
              </a:rPr>
              <a:t>Start – End Observed  Mr(expt)  Mr(calc)   Delta    Miss     Sequence</a:t>
            </a:r>
            <a:r>
              <a:rPr b="1" lang="zh-CN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1 - 112    1366.7913     1365.7840    1365.6677    0.1164        0      R.DNIQAYPGVSFR.Y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1 - 112    1366.7913     1365.7840    1365.6677    0.1164        0      R.DNIQAYPGVSFR.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5 - 168    1514.8097     1513.8024    1513.6837    0.1187        0      R.FDAFADTFPPSSG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5 - 168    1514.8097     1513.8024    1513.6837    0.1187        0      R.FDAFADTFPPSSG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9 - 179    1384.7714     1383.7641    1383.6605    0.1036        1      R.FRDDYMTPIA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80 - 199    2220.3210     2219.3137    2219.1666    0.1471        0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FLATTGAPLLANVYPYFAYK.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0 - 289    2155.3081     2154.3008    2154.0929    0.2079        0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K.VGASVNNAQTYNQGLINHVR.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20 - 336    1941.9685     1940.9612    1940.9420    0.0192        1      K.HFGLFNPNKSPSYSISF.-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20 - 336    1941.9685     1940.9612    1940.9420    0.0192        1      K.HFGLFNPNKSPSYSISF.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9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NIQAYPGVSF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366.79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9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DAFADTFPPSSG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14.81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684360" y="109440"/>
            <a:ext cx="60483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8/7.02   Mr obsd/calcd: 34371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9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04920" y="2852280"/>
            <a:ext cx="861048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KMGFAPMLSV AVLLGTLAAF PAAVHSIGVC YGVVANNLPG PSEVVQLYR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NIQAYPGVS FRYIAVGNEV QGSDTANIL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VNSALV AAGLGNIK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DA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FPPSSGRFR DDYMTPI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 LATTGAPLLA NVYPYFAYK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QESGQKNIM LNYATFQPGT TVVDNGNRLT YTCLFDAMVD SIYAALEKA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PSVSVVVSE SGWPSAGG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ASVNNAQT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GLFNP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P SYSIS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-360" y="1447920"/>
            <a:ext cx="9372600" cy="304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– End Observed   Mr(expt)    Mr(calc)    Delta   Miss         Sequence</a:t>
            </a: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1 - 112   1366.8054     1365.7981   1365.6677    0.1305     0          R.DNIQAYPGVSFR.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1 - 112   1366.8054     1365.7981   1365.6677    0.1305     0          R.DNIQAYPGVSFR.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13 - 133   2219.2974     2218.2901   2218.1051    0.1850     0 R.YIAVGNEVQGSDTANILPAMR.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5 - 168   1514.8401     1513.8328   1513.6837    0.1491     0           R.FDAFADTFPPSSGR.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5 - 168   1514.8401     1513.8328   1513.6837    0.1491     0           R.FDAFADTFPPSSG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9 - 179   1384.7947     1383.7874   1383.6605    0.1269     1           R.FRDDYMTPIA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0 - 289   2155.2869     2154.2796   2154.0929    0.1867     0 K.VGASVNNAQTYNQGLINHVR.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0 - 289   2155.2869     2154.2796   2154.0929    0.1867     0 K.VGASVNNAQTYNQGLINHVR.G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20 - 328   1073.6486     1072.6413   1072.5454    0.0960     0           K.HFGLFNPNK.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0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NIQAYPGVSF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366.8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0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DAFADTFPPSSG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514.8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" descr=""/>
          <p:cNvPicPr/>
          <p:nvPr/>
        </p:nvPicPr>
        <p:blipFill>
          <a:blip r:embed="rId1"/>
          <a:stretch/>
        </p:blipFill>
        <p:spPr>
          <a:xfrm>
            <a:off x="3049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0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GASVNNAQTYNQGLINHV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2155.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" descr=""/>
          <p:cNvPicPr/>
          <p:nvPr/>
        </p:nvPicPr>
        <p:blipFill>
          <a:blip r:embed="rId1"/>
          <a:stretch/>
        </p:blipFill>
        <p:spPr>
          <a:xfrm>
            <a:off x="457200" y="11430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8/7.02   Mr obsd/calcd:32696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0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04920" y="2066400"/>
            <a:ext cx="8610480" cy="280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 maativsvka 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qifds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np tvevdvccsd gtfa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avps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astgvyeal el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ggsdy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gkgvskavdn vnsviapali gkdptsqael dnfmvqqldg tknewgwckq klganailav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slaickagai ikkiplyqhi anlagnkqlv lpvpafnvin ggshagnkla mqefmilptg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aasfkeamkm gvevyhnlks vikkkygqda tnvgdeggfa pniqenkegl ellktaiek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gytgkvvigm dvaasefynd kdktydlnfk eenndgsqki sgdslknvyk sfvseypiv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iedpfdqddw ehyakmtaei geqvqivgdd llvtnptrva kaiqekscna lllkvnqig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6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tesieavkm sk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gwgvmt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h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getedt fiadlavgla tgqiktgapc rserla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ynq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l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ieeelga aavyaga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r apvep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400800" y="5791320"/>
            <a:ext cx="17524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04920" y="2837880"/>
            <a:ext cx="8610480" cy="182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KMGFAPMLSV AVLLGTLAAF PAAVHSIGVC YGVVANNLPG PSEVVQLYR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NIQAYPGVS FRYIAVGNEV QGSDTANIL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VNSALV AAGLGNIK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DAFAD TFPPSSGRF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DYMTPI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 LATTGAPLLA NVYPYFAYK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QESGQKNIM LNYATFQPGT TVVDNGNRLT YTCLFDAMVD SIYAALEKA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PSVSVVVSE SGWPSAGG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 GASVNNAQT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 FGLFNP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P SYSISF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-360" y="1447560"/>
            <a:ext cx="9372600" cy="335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– End    Observed    Mr(expt)      Mr(calc)    Delta  Miss     Sequenc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1 - 112       1366.7914        1365.7841      1365.6677    0.1165   0          R.DNIQAYPGVSF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1 - 112       1366.7914        1365.7841      1365.6677    0.1165   0          R.DNIQAYPGVSFR.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3 - 133       2219.3118        2218.3045      2218.1051    0.1994   0          R.YIAVGNEVQGSDTANILPAMR.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3 - 133       2235.3008        2234.2935      2234.1001    0.1935   0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 R.YIAVGNEVQGSDTANILPAMR.N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Oxidation (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5 - 168       1514.8196        1513.8123      1513.6837    0.1286   0           R.FDAFADTFPPSSGR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5 - 168       1514.8196        1513.8123      1513.6837    0.1286   0           R.FDAFADTFPPSSGR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79       1384.7800        1383.7727      1383.6605    0.1122   1           R.FRDDYMTPIAR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79       1400.7714        1399.7641      1399.6554    0.1087   1           R.FRDDYMTPIAR.F Oxidation (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0 - 289       2155.2954        2154.2881      2154.0929    0.1952   0           K.VGASVNNAQTYNQGLINHVR.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28       1073.6267        1072.6194      1072.5454    0.0741   0           K.HFGLFNPNK.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1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NIQAYPGVSF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366.7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1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DAFADTFPPSS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14.8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"/>
          <p:cNvSpPr/>
          <p:nvPr/>
        </p:nvSpPr>
        <p:spPr>
          <a:xfrm>
            <a:off x="684360" y="109440"/>
            <a:ext cx="5945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405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8/6.83 Mr obsd/calcd:33545/35810 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6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04920" y="2746440"/>
            <a:ext cx="861048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makmgfapml svavllgtla afpaavhsig vcygvvannl pgpsevvqly rskgidsmr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yfadaaalna lsgsniglim dvgngnlssl asspsaaagw v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niqaypg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sf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yiavg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evqgsdtani lpamrnvnsa lvaaglgnik vstsv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daf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dtfppssgr frddymtpi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lattgapl lanvypyfay kddqesgqkn imlnyatfqp gttvvdngnr ltytclfdam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vdsiyaalek agtpsvsvvv sesgwpsagg kv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asvnnaq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tynqglinhv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gtpkkrr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etyifamfd engkpgdeie khfglfnpnk spsysis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7010280" y="5334120"/>
            <a:ext cx="1219320" cy="162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" descr=""/>
          <p:cNvPicPr/>
          <p:nvPr/>
        </p:nvPicPr>
        <p:blipFill>
          <a:blip r:embed="rId1"/>
          <a:stretch/>
        </p:blipFill>
        <p:spPr>
          <a:xfrm>
            <a:off x="457200" y="1447920"/>
            <a:ext cx="7939080" cy="3352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2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NIQAYPGVSF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405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6095880" y="127080"/>
            <a:ext cx="29210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+ 1366.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" descr=""/>
          <p:cNvPicPr/>
          <p:nvPr/>
        </p:nvPicPr>
        <p:blipFill>
          <a:blip r:embed="rId1"/>
          <a:stretch/>
        </p:blipFill>
        <p:spPr>
          <a:xfrm>
            <a:off x="45720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2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DAFADTFPPSSG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405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14.76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3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"/>
          <p:cNvSpPr/>
          <p:nvPr/>
        </p:nvSpPr>
        <p:spPr>
          <a:xfrm>
            <a:off x="684360" y="109440"/>
            <a:ext cx="5945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73/4.98 Mr obsd/calcd:30314/5854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6" name="" descr=""/>
          <p:cNvPicPr/>
          <p:nvPr/>
        </p:nvPicPr>
        <p:blipFill>
          <a:blip r:embed="rId1"/>
          <a:stretch/>
        </p:blipFill>
        <p:spPr>
          <a:xfrm>
            <a:off x="457200" y="13716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533520" y="1676520"/>
            <a:ext cx="8229600" cy="3886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04920" y="2226240"/>
            <a:ext cx="861048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 mavnhklsal lvatalplll lstadageig vcygrdasnl idppevvkll nansitmvr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ydtdptvlna lantgikvmv mlpnkdlasa gadvgsatnw vknnvvpyln qgtlingvav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gnevfkqqpe ltgmlvsamq nvqmalanln ladgikvstp iafdaldvsf ppsdgrfkd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iaqsvmkpmi dflvrtgsyl lvnlypmyaa adpsthisie yatfrpnsgv ldektgimy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slfdaeldav yaaiskvsgg slraslaqgd qmlvqvaetg hssgntfggp vvveadadl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iatipna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ynnglir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l sgspgkhdvs ayifslfnen lkpgpategh fglfypngqq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vyevnfqggr spcptnaswc vanpnvdnaa lqraldwacn ngadcsaiql gkacyepnt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vahasyafnd yyqrkgqasg tcnfngvafi vykpspsicd pnpswcvakd svgeaqlqn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dyacgscad csaiqrgaqc fnpdt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aha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tyafndyyqt ag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sgscdf agaativtqq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pkigncllpp nn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943600" y="5257800"/>
            <a:ext cx="106668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3" name="" descr=""/>
          <p:cNvPicPr/>
          <p:nvPr/>
        </p:nvPicPr>
        <p:blipFill>
          <a:blip r:embed="rId1"/>
          <a:stretch/>
        </p:blipFill>
        <p:spPr>
          <a:xfrm>
            <a:off x="457200" y="1905120"/>
            <a:ext cx="8153280" cy="259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3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YNNGL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920.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6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3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AHATYAFNDYYQTAG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948.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9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"/>
          <p:cNvSpPr/>
          <p:nvPr/>
        </p:nvSpPr>
        <p:spPr>
          <a:xfrm>
            <a:off x="684360" y="109440"/>
            <a:ext cx="7164360" cy="13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Arial"/>
              </a:rPr>
              <a:t>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CBI accession No.: NP_001059883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42/4.98     Mr obsd/calcd:29542/ 585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core: 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7772400" y="304920"/>
            <a:ext cx="16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092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aphicFrame>
        <p:nvGraphicFramePr>
          <p:cNvPr id="173" name=""/>
          <p:cNvGraphicFramePr/>
          <p:nvPr/>
        </p:nvGraphicFramePr>
        <p:xfrm>
          <a:off x="3543480" y="3110040"/>
          <a:ext cx="2057400" cy="637920"/>
        </p:xfrm>
        <a:graphic>
          <a:graphicData uri="http://schemas.openxmlformats.org/drawingml/2006/table">
            <a:tbl>
              <a:tblPr/>
              <a:tblGrid>
                <a:gridCol w="914400"/>
                <a:gridCol w="1143000"/>
              </a:tblGrid>
              <a:tr h="6379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PI obsd/calc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宋体"/>
                        </a:rPr>
                        <a:t>Mr obsd/calc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6840" y="571464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/>
          </p:nvPr>
        </p:nvSpPr>
        <p:spPr>
          <a:xfrm>
            <a:off x="609480" y="144792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VNHKLSAL LVATALPLLL LSTADAGEIG VCYG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ASN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DPPEV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NANSITMVRI YDTDPTVLNA LANTGIKVMV MLPNKDLASA GADVGSATNW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KNNVVPYLN QGTLINGVAV GNEVFKQQPE LTGMLVSAMQ NVQMALANL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ADGIKVSTP IAFDALDVSF PPSDGRFKDS IAQSVMKPMI DFLVRTGSY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VNLYPMYAA ADPSTHISIE YATFRPNSGV LDEKTGIMYF SLFDAELDA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YAAISKVSGG SLRASLAQGD QMLVQVAETG HSSGNTFGGP VVVEADADL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IATIPNA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YNNGL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VL SGSPGKHDVS AYIFSLFNEN LKPGPATEG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FGLFYPNGQQ VYEVNFQGGR SPCPTNASWC VANPNVDNAA LQRALDWAC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GADCSAIQL GKACYEPNTL VAHASYAFND YYQRKGQASG TCNFNGVAF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YKPSPSICD PNPSWCVAKD SVGEAQLQNA LDYACGSCAD CSAIQRGAQ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FNPDT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AH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YAFNDYYQ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GSCDF AGAATIVTQQ PKIGNCLLPP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N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0" y="1494000"/>
            <a:ext cx="9144000" cy="536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Observed    Mr(expt)   Mr(calc)      Delta     Miss     Sequence</a:t>
            </a:r>
            <a:r>
              <a:rPr b="0" lang="zh-CN" sz="3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6 - 48            1396.7604    1395.7531    1395.7245     0.0286      0       R.DASNLIDPPEVVK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0 - 317          920.5458      919.5385      919.4875      0.0510     0          K.AYNNGLIR.R</a:t>
            </a:r>
            <a:r>
              <a:rPr b="1" lang="zh-CN" sz="2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07 - 523         1947.9863    1946.9790   1946.8911      0.0880     0  K.VAHATYAFNDYYQTAGR.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07 - 523         1947.9863    1946.9790   1946.8911      0.0880     0  K.VAHATYAFNDYYQTAGR.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Arial"/>
              </a:rPr>
              <a:t>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eptide sequences: VAHATYAFNDYYQTA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CBI accession No.: NP_0010598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core: 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947.98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0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508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Arial"/>
              </a:rPr>
              <a:t>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CBI accession No.: NP_001055377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57/5.92  Mr obsd/calcd:30078/347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core:1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3" name="" descr=""/>
          <p:cNvPicPr/>
          <p:nvPr/>
        </p:nvPicPr>
        <p:blipFill>
          <a:blip r:embed="rId1"/>
          <a:stretch/>
        </p:blipFill>
        <p:spPr>
          <a:xfrm>
            <a:off x="611280" y="1341360"/>
            <a:ext cx="8294760" cy="508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3%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0" y="2192400"/>
            <a:ext cx="89154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MASQGVASMF ALALLLGAFA SIPQKAEAIG VCYGMSANNL PPASSVVGM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RSNGITSMRL YAPDQAALQS VGGTGISVVV GAPNDVLSNL AASPAAAASW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VR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NNIQAYPS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VSFRYVAVGN EVAGGATSSL VPAMENVRGA LVSAGLGHIK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TTSVSQALL AVYSPPSAAE FTGESQAFMA PVLSFLARTG APLLANIYP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FSYTYSQGSV DVSYALFTAA GTVVQDGAYG YQNLFDTTVD AFYAAMAKHG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GSGVSLVVSE TGWPSAGGMS ASPANAR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IYN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QNLINHVG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 TPR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HPGAIET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301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YVFSMFNENQ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AGVEQNWG LFYPNMQHVY PIS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8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RAPVEP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Q429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978.57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457200" y="14479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-81000" y="1557360"/>
            <a:ext cx="914400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Observed   Mr(expt)     Mr(calc)     Delta     Miss               Sequ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03 - 114     1395.7161   1394.7088  1394.6942  0.0146    0      R.NNIQAYPSVSFR.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15 - 138     2391.2478   2390.2405  2390.1899  0.0506    0   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R.YVAVGNEVAGGATSSLVPAMENVR.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39 - 150     1122.6628   1121.6555  1121.6556  -0.0001   0      R.GALVSAGLGHIK.V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78 - 289     1440.7871   1439.7798  1439.7633  0.0165    0      R.IYNQNLINHVGR.G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94 - 311     2112.0930   2111.0857  2110.9781  0.1076    0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HPGAIETYVFSMFNENQK.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5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fr-FR" sz="1800" spc="-1" strike="noStrike">
                <a:solidFill>
                  <a:srgbClr val="000000"/>
                </a:solidFill>
                <a:latin typeface="Times New Roman"/>
              </a:rPr>
              <a:t>NNIQAYPSVSF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NP_001055377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395.71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30592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5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fr-FR" sz="1800" spc="-1" strike="noStrike">
                <a:solidFill>
                  <a:srgbClr val="000000"/>
                </a:solidFill>
                <a:latin typeface="Times New Roman"/>
              </a:rPr>
              <a:t>IYNQNLINHV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NP_00105537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440.78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5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30556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AA4691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45/5.77  Mr obsd/calcd:33038/3287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1%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0" y="2204280"/>
            <a:ext cx="8915400" cy="253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MASATNSSLS LMLLVAAAMA SVASAQLSAT FYDTSCPNAL STI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VITAA</a:t>
            </a:r>
            <a:r>
              <a:rPr b="1" lang="zh-CN" sz="3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 VNSEARMGAS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LL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HFHDCF VQGCDASVLL SGQEQNAGPN VGSLR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GFSVI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DNA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RVEAI CNQTVSCADI LAVAAR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DSVV ALGGPSWTVL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LG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RDSTTAS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EALANTDLPA PSSSLAELIG NFSRKGLDAT DMVALSGAHT IGQAQCQNF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DRIYNETNID SAFATQRQAN CPRPTGSGDS NLAPVDTTTP NAFDNAYYSN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LSNK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GLLHS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DQVLFNGGSA DNTVRNFASN AAAFSSAFTT AMVKMGNISP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zh-CN" sz="1800" spc="-1" strike="noStrike">
                <a:solidFill>
                  <a:srgbClr val="ff0000"/>
                </a:solidFill>
                <a:latin typeface="Arial"/>
              </a:rPr>
              <a:t>LTGTQGQI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 SCSKVN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-63360" y="1341360"/>
            <a:ext cx="914400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 Observed    Mr(expt)     Mr(calc)    Delta     Miss               Sequ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5 - 56     1217.6774   1216.6701  1216.6411  0.0290      0     K.SVITAAVNSEAR.M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7 - 63       747.4343    746.4270     746.4109  0.0162      0     R.MGASLLR.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7 - 63       763.4225    762.4152     762.4058  0.0094      0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MGASLLR.L Oxidation(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96 - 104     950.5002    949.4929     949.4868  0.0061      0     R.GFSVIDNAK.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7 - 143   1726.9913   1725.9840  1725.9413  0.0427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DSVVALGGPSWTVLLGR.R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56 - 275  2100.1057   2099.0984  2099.0395  0.0589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GLLHSDQVLFNGGSADNTVR.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56 - 275  2100.1057   2099.0984  2099.0395  0.0589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GLLHSDQVLFNGGSADNTVR.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76 - 294  1935.9938   1934.9865  1934.9196  0.0670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NFASNAAAFSSAFTTAMVK.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95 - 309  1572.8590   1571.8517  1571.8089  0.0428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MGNISPLTGTQGQIR.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95 - 309  1572.8590   1571.8517  1571.8089  0.0428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MGNISPLTGTQGQIR.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95 - 309  1588.8595   1587.8522  1587.8038  0.0484      0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K.MGNISPLTGTQGQIR.LOxidation(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8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GLLHSDQVLFNGGSADNTVR 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AA469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2100.10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7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30592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8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MGNISPLTGTQGQI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AA469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1572.85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0" name="" descr=""/>
          <p:cNvPicPr/>
          <p:nvPr/>
        </p:nvPicPr>
        <p:blipFill>
          <a:blip r:embed="rId1"/>
          <a:stretch/>
        </p:blipFill>
        <p:spPr>
          <a:xfrm>
            <a:off x="609480" y="1523880"/>
            <a:ext cx="830592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79/5.51   Mr obsd/calcd:37297/326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3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04920" y="2837880"/>
            <a:ext cx="8610480" cy="182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ASSVSLM LLVAAAMASA ASAQLSATFY DTSCPNALST I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AVTAA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EPRMGAS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HFHDCFVQ GCDASVLLSG QEQNAGPNAG SL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FNVVD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QVEAICS QTVSCADILA VAA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SVV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GPSWTVLL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STTANE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QANTDLPAPS SSLAELIGNF SRKGLDVTDM VALSGAHTIG QAQCQNFRD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YNETNIDSS FATALKANCP RPTGSGDSNL APLDTTTPNA FDSAYYTNL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N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LLHSDQ VLFNGGSTDN T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FSSNTA AFNSAFTAAM V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GNISPL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T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NC SKV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8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VPSGASTGVYEALEL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Q429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1791.05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PlaceHolder 2"/>
          <p:cNvSpPr>
            <a:spLocks noGrp="1"/>
          </p:cNvSpPr>
          <p:nvPr>
            <p:ph/>
          </p:nvPr>
        </p:nvSpPr>
        <p:spPr>
          <a:xfrm>
            <a:off x="-360" y="1447920"/>
            <a:ext cx="93726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– End  Observed  Mr(expt)   Mr(calc)   Delta    Miss          Sequence</a:t>
            </a: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 - 54       1201.7057    1200.6984   1200.6098  0.0886    0                 K.SAVTAAVNSEPR.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5 - 61        733.4464      732.4391     732.3952   0.0439    0                 R.MGASLV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94 - 102     1005.5838    1004.5765   1004.5290  0.0475    0                 R.GFNVVDNIK.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5 - 141     1727.0785    1726.0712   1725.9413  0.1299    0  R.DSVVALGGPSWTVLLGR.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5 - 141     1727.0785    1726.0712   1725.9413  0.1299    0  R.DSVVALGGPSWTVLLGR.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5 - 142     1883.2117    1882.2044   1882.0424  0.1620    1  R.DSVVALGGPSWTVLLGRR.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4 - 273     2130.2302    2129.2229   2129.0501  0.1728    0  K.GLLHSDQVLFNGGSTDNTVR.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4 - 273     2130.2302    2129.2229   2129.0501  0.1728    0  K.GLLHSDQVLFNGGSTDNTVR.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72.9327    1571.9254   1571.8089  0.1165    0                 K.MGNISPLTGTQGQI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72.9327    1571.9254   1571.8089  0.1165    0                 K.MGNISPLTGTQGQI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88.9139    1587.9066   1587.8038  0.1028    0  K.MGNISPLTGTQGQIR.L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Oxidation (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0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SVVALGGPSWTVLL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727.08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2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0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LLHSDQVLFNGGSTDNTV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130.23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5" name="" descr=""/>
          <p:cNvPicPr/>
          <p:nvPr/>
        </p:nvPicPr>
        <p:blipFill>
          <a:blip r:embed="rId1"/>
          <a:stretch/>
        </p:blipFill>
        <p:spPr>
          <a:xfrm>
            <a:off x="457200" y="11430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0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MGNISPLTGTQGQI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8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72.93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80/5.51   Mr obsd/calcd:36942/326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24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1" name="" descr=""/>
          <p:cNvPicPr/>
          <p:nvPr/>
        </p:nvPicPr>
        <p:blipFill>
          <a:blip r:embed="rId1"/>
          <a:stretch/>
        </p:blipFill>
        <p:spPr>
          <a:xfrm>
            <a:off x="3049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04920" y="2837880"/>
            <a:ext cx="8610480" cy="182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ASSVSLM LLVAAAMASA ASAQLSATFY DTSCPNALST I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AVTAAV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  SEPRMGAS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HFHDCFVQ GCDASVLLSG QEQNAGPNAG SL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FNVV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QVEAICS QTVSCADILA VAA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SVV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GPSWTVLLG 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STTANE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QANTDLPAPS SSLAELIGNF SRKGLDVTDM VALSGAHTIG QAQCQNFRD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YNETNIDSS FATALKANCP RPTGSGDSNL APLDTTTPNA FDSAYYTN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N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LLHSDQ VLFNGGST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FSSNTA AFNSAFTAAM V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GNISPL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T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NC SKV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/>
          </p:nvPr>
        </p:nvSpPr>
        <p:spPr>
          <a:xfrm>
            <a:off x="-360" y="1371240"/>
            <a:ext cx="9372600" cy="380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000000"/>
                </a:solidFill>
                <a:latin typeface="Arial"/>
              </a:rPr>
              <a:t>Start – End  Observed  Mr(expt)  Mr(calc)  Delta   Miss       Sequence</a:t>
            </a: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           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 - 54       1201.7345      1200.7272   1200.6098    0.1174      0         K.SAVTAAVNSEPR.M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5 - 61         749.4606       748.4533     748.3901     0.0632      0         R.MGASLVR.L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Oxidation (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94 - 102     1005.6284      1004.6211   1004.5290    0.0921      0         R.GFNVVDNIK.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5 - 141     1727.1128      1726.1055   1725.9413    0.1642      0   R.DSVVALGGPSWTVLLGR.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5 - 141     1727.1128      1726.1055   1725.9413    0.1642      0   R.DSVVALGGPSWTVLLGR.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4 - 273     2130.2659      2129.2586   2129.0501    0.2085      0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K.GLLHSDQVLFNGGSTDNTVR.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4 - 273     2130.2659      2129.2586   2129.0501    0.2085      0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K.GLLHSDQVLFNGGSTDNTVR.N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72.9630      1571.9557   1571.8089    0.1468      0         K.MGNISPLTGTQGQIR.L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72.9630      1571.9557   1571.8089    0.1468      0         K.MGNISPLTGTQGQI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93 - 307     1588.9489      1587.9416   1587.8038    0.1378      0 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MGNISPLTGTQGQIR.L Oxidation (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1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SVVALGGPSWTVLL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727.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0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1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LLHSDQVLFNGGSTDNTV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8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130.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3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1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MGNISPLTGTQGQIR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06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72.9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6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C4917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54/5.42   Mr obsd/calcd:58297/4798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54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5/4.99  Mr obsd/calcd:37394/3804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9" name="" descr=""/>
          <p:cNvPicPr/>
          <p:nvPr/>
        </p:nvPicPr>
        <p:blipFill>
          <a:blip r:embed="rId1"/>
          <a:stretch/>
        </p:blipFill>
        <p:spPr>
          <a:xfrm>
            <a:off x="30492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8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04920" y="2622960"/>
            <a:ext cx="8610480" cy="204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RTSATAG MLLLAAAAAL VCSSAAARMP PLAKGLSLGY YDASCPQAE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VVFEFLQDAI A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VGLAA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HFHDCFV QGCDASILLD STPTEKSEK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PPNKTLR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 AFDAIDD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 LLDRECGDTV VSCSDIVTLA A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SVLLAG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PWYDVPL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 DGSSFASEDA VLSALPSPDS NVTTLLEALG KLKLDAHDL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LSGAHTVGI AHCTSFDKRL FPQVDPTMDK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WFAGH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TC PVLNTNDTT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DIRTPNTFD N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YYVDLQN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GLFTSDQGL FFNATTKPIV TKFAVDQSA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FDQYVYSVVK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GMIEVLTGS 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RCSV SNAAAAGDRA WSVVETVAE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ESLV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PlaceHolder 2"/>
          <p:cNvSpPr>
            <a:spLocks noGrp="1"/>
          </p:cNvSpPr>
          <p:nvPr>
            <p:ph/>
          </p:nvPr>
        </p:nvSpPr>
        <p:spPr>
          <a:xfrm>
            <a:off x="-360" y="1447920"/>
            <a:ext cx="9372600" cy="26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000000"/>
                </a:solidFill>
                <a:latin typeface="Arial"/>
              </a:rPr>
              <a:t>Start – End  Observed  Mr(expt)  Mr(calc)   Delta    Miss      Sequence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63 - 72         998.7067        997.6994     997.5920      0.1074     0            K.DVGLAAALI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63 - 72         998.7067        997.6994     997.5920      0.1074     0            K.DVGLAAALIR.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10 - 119      1122.6510      1121.6437   1121.5353     0.1084     0            K.SAFDAIDDL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43 - 159      1815.1129      1814.1056   1813.9362     0.1694     0  R.DSVLLAGGPWYDVPLGR.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31 - 237       858.5327        857.5254     857.4548      0.0707     0            K.WFAGHLK.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63 - 270      1070.6306      1069.6233   1069.5192     0.1041     0            K.YYVDLQNR.Q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63 - 270      1070.6306      1069.6233   1069.5192     0.1041     0            K.YYVDLQNR.Q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1 - 325      1619.9779      1618.9706   1618.8170     0.1536     0  K.MGMIEVLTGSQGQIR.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2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VGLAAAL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54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998.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8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2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YYVDLQN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454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070.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1" name="" descr=""/>
          <p:cNvPicPr/>
          <p:nvPr/>
        </p:nvPicPr>
        <p:blipFill>
          <a:blip r:embed="rId1"/>
          <a:stretch/>
        </p:blipFill>
        <p:spPr>
          <a:xfrm>
            <a:off x="304920" y="11430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AH6931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4.88/4.83  Mr obsd/calcd:46878/3534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4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0" y="2607480"/>
            <a:ext cx="8915400" cy="182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AAALLGML MMMSSAPEMK VEAAGGLSVG FYAESCPKAE AIVRDTVTK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FE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PGTP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IRLFFHDC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CDASVLL ESTPGNKAER DNKANNPSL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FDVVDDAKD LLEKECPHTV SCADILSLVA 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SAYLAGG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FEIPT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FVS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DEV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NVPHPEFGA 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LLKNFTAK GFTAEEMVTL SGAHSIGTS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SSFTNRLYK YYGTYGTDPS MPAAYAADMK SKCPPETAAQQDATMVQLD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TPF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DNQ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Y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VLAGNVT FASDVALLDT PETAAL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AGDPAAWL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AAALVKVS 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DVLTGGE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NCSRI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2"/>
          <p:cNvSpPr>
            <a:spLocks noGrp="1"/>
          </p:cNvSpPr>
          <p:nvPr>
            <p:ph/>
          </p:nvPr>
        </p:nvSpPr>
        <p:spPr>
          <a:xfrm>
            <a:off x="0" y="1676520"/>
            <a:ext cx="9144000" cy="365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 Observed    Mr(expt)     Mr(calc)   Delta    Miss       Sequ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900" spc="-1" strike="noStrike">
                <a:solidFill>
                  <a:srgbClr val="000000"/>
                </a:solidFill>
                <a:latin typeface="Arial"/>
              </a:rPr>
              <a:t>    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4 - 63         1010.6557     1009.6484     1009.5556  0.0928       0            K.APGTPADLI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64 - 72         1183.6493     1182.6420     1182.5644  0.0776       0            R.LFFHDCFVR.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32 - 148       1782.0391     1781.0318     1780.8631  0.1687       0 R.DSAYLAGGLDFEIPTGR.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6 - 171       1767.9990     1766.9917     1766.8475  0.1443       0 K.EDEVLSNVPHPEFGAK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6 - 262        989.5029       988.4956       988.4072   0.0884       0            K.MDNQYYR.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56 - 262        989.5029       988.4956       988.4072   0.0884       0            K.MDNQYYR.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89 - 301       1374.8436     1373.8363     1373.7091  0.1272       0 R.LYAAGDPAAWLA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89 - 301       1374.8436     1373.8363     1373.7091  0.1272       0 R.LYAAGDPAAWLA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2 - 323       1258.7833     1257.7760     1257.6564  0.1196       0            K.LDVLTGGEGEI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6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MDNQYY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CAH6931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89.50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3" name="" descr=""/>
          <p:cNvPicPr/>
          <p:nvPr/>
        </p:nvPicPr>
        <p:blipFill>
          <a:blip r:embed="rId1"/>
          <a:stretch/>
        </p:blipFill>
        <p:spPr>
          <a:xfrm>
            <a:off x="304920" y="1219320"/>
            <a:ext cx="830556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6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YAAGDPAAWLAR </a:t>
            </a:r>
            <a:r>
              <a:rPr b="0" lang="fr-FR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CAH6931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374.84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6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2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04920" y="2608920"/>
            <a:ext cx="86104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ATIVSVKA 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QIFDS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NP TVEVDVCCSD GTFA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AVP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GASTGVYEA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GGSDYL GKGVSKAVDN VNSVIAPALI GKDPTSQAEL DNFMVQQLD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KNEWGWCKQ KLGANAILAV SLAICKAGAI IK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IPLYQH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NLAG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L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PVPAFNVIN GGSHAGNKLA MQEFMILPTG AASFKEAMKM GVEVYHNLK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IKKKYGQDA TNVGDEGGFA PNIQENKEGL ELLKTAIEKA GYTG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VIG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 DVAASEFYN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KTYDLNFK EENNDGSQKI SGDSLKNVYK SFVSEYPI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IEDPFDQDDW EHYA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TAEI GEQVQIVGDD LLVTNP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 KAIQEKSCN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LKVNQIGS VTESIEAVKM SK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GWGVM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H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GETEDT FIAELAVGL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GQIKTGAPC RSERLA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YN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L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EEELGA AAVYAGA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FR APVEP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48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94/5.75   Mr obsd/calcd:35960/3556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9%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04920" y="2404800"/>
            <a:ext cx="861048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KEPM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LV TGAAGQIGYA LVPMI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VM LGADQPVILH MLDIPPAT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NGL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ELV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AFPL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IV ATTDVVEACT GVNVAVMVGG FPR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GMER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VMSKNVSIY KSQASALEAH AAPNCK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LV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NPANTNALI LKEFAPSIP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ITCLTRLD HN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ALGQIS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KLNVQVTDVK NAIIWGNHS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TQYPDVNHA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KTPSGEKPV RELVADDEWL NTEFISTVQ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AAIIKARK QSSALSAAS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CDHIRDWVL GTPEGTFVSM GVYSDGSYGV PAGLIYSFPV TCSGGEWTI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QGLPIDEFSR KKMDATAQEL SEEKTLAYSC L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2"/>
          <p:cNvSpPr>
            <a:spLocks noGrp="1"/>
          </p:cNvSpPr>
          <p:nvPr>
            <p:ph/>
          </p:nvPr>
        </p:nvSpPr>
        <p:spPr>
          <a:xfrm>
            <a:off x="-57240" y="1628640"/>
            <a:ext cx="9144000" cy="360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  Observed    Mr(expt)     Mr(calc)     Delta     Miss               Sequenc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 - 27         2000.1315     1999.1242      1999.1288     -0.0045      0      R.VLVTGAAGQIGYALVPMIA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 - 27         2016.1357      2015.1284      2015.1237     0.0048      0     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R.VLVTGAAGQIGYALVPMIAR.G Oxidation (M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6 - 67         1346.7371     1345.7298      1345.7315     -0.0017      0       K.MELVDAAFPLL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6 - 67         1346.7371     1345.7298      1345.7315     -0.0017      0       K.MELVDAAFPLL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6 - 67         1362.7399     1361.7326      1361.7264      0.0062      0       K.MELVDAAFPLLK.G Oxidation (M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95 - 100         749.3598       748.3525        748.3537     -0.0012     1        K.EGMER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7 - 142       1649.9939     1648.9866      1648.9875     -0.0009     0        K.VLVVANPANTNALIL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3 - 151       1017.5263     1016.5190      1016.5178      0.0012     0        K.EFAPSIPE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4 - 171         845.4759       844.4686        844.4654      0.0032     0        R.ALGQISEK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2 - 180       1015.5713     1014.5640      1014.5709     -0.0069     0       K.LNVQVTDV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1 - 202       2452.2212     2451.2139      2451.1931      0.0209     0       K.NAIIWGNHSSTQYPDVNHATV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1 - 202       2452.2212     2451.2139      2451.1931      0.0209     0       K.NAIIWGNHSSTQYPDVNHATV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3 - 211        970.5294       969.5221        969.5243      -0.0022     0       K.TPSGEKPVR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2 - 231      2393.1587     2392.1514      2392.1546     -0.0032     0       R.ELVADDEWLNTEFISTVQQR.G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8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MELVDAAFPLL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48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346.73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8" name="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830592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8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NAIIWGNHSSTQYPDVNHATV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48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2452.22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1" name="" descr=""/>
          <p:cNvPicPr/>
          <p:nvPr/>
        </p:nvPicPr>
        <p:blipFill>
          <a:blip r:embed="rId1"/>
          <a:stretch/>
        </p:blipFill>
        <p:spPr>
          <a:xfrm>
            <a:off x="533520" y="1523880"/>
            <a:ext cx="8305560" cy="472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"/>
          <p:cNvSpPr/>
          <p:nvPr/>
        </p:nvSpPr>
        <p:spPr>
          <a:xfrm>
            <a:off x="684360" y="109440"/>
            <a:ext cx="61736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74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86/5.01   Mr obsd/calcd:71212/5685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4" name="" descr=""/>
          <p:cNvPicPr/>
          <p:nvPr/>
        </p:nvPicPr>
        <p:blipFill>
          <a:blip r:embed="rId1"/>
          <a:stretch/>
        </p:blipFill>
        <p:spPr>
          <a:xfrm>
            <a:off x="45720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304920" y="2348280"/>
            <a:ext cx="861048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 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maiskawisl llalavvlsa paaraeeaaa aeeggdaaae avltldadgf deavakhpfm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vvefyapwcg hckklapeye kaaqelskhd ppivlakvda ndeknkplat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kyeiqgfptl</a:t>
            </a:r>
            <a:r>
              <a:rPr b="0" lang="zh-CN" sz="18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ifrnqgkni qeykgpreae giveylkkqv gpaskeiksp edatnliddk kiyivgif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sgteytnfi evaekl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dy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fghtlhanh lprgdaave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plv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fkpfd elvvdskdf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vtalekfida sstpkvvtfd 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npdnhpyll</a:t>
            </a:r>
            <a:r>
              <a:rPr b="0" lang="zh-CN" sz="1800" spc="-1" strike="noStrike">
                <a:solidFill>
                  <a:srgbClr val="ff33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fqssaaka mlflnfstgp fesf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vyyg</a:t>
            </a:r>
            <a:r>
              <a:rPr b="0" lang="zh-CN" sz="18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aeefkd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i kfligdieas qgafqyfglr edqvpliiiq dgeskkflka hvepdqivsw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keyfdgkls pfrksepipe vndepv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vv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dnvhdfvf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sgknvlvefy apwcghckk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apildeaatt lksdkdvvia kmdatandvp sefdvqgypt lyfvtpsg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m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pyesg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ta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eivdfikknk etagqakeka esapaeplkd e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6095880" y="5334120"/>
            <a:ext cx="2210040" cy="203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/>
          </p:nvPr>
        </p:nvSpPr>
        <p:spPr>
          <a:xfrm>
            <a:off x="-360" y="1447560"/>
            <a:ext cx="9372600" cy="335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2" name="" descr=""/>
          <p:cNvPicPr/>
          <p:nvPr/>
        </p:nvPicPr>
        <p:blipFill>
          <a:blip r:embed="rId1"/>
          <a:stretch/>
        </p:blipFill>
        <p:spPr>
          <a:xfrm>
            <a:off x="304920" y="1447920"/>
            <a:ext cx="8610480" cy="426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1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MVPYESG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743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938.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5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1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DAAVERPLV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74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182.7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8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-108360" y="1412640"/>
            <a:ext cx="9372600" cy="335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– End  Observed  Mr(expt)    Mr(calc)   Delta    Miss            Sequ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 - 17      765.4486      764.4413      764.3817   0.0596      0                  R.QIFDSR.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6 - 53     1791.0734    1790.0661    1789.9209  0.1452      0    R.AAVPSGASTGVYEALEL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6 - 53     1791.0734    1790.0661    1789.9209  0.1452      0    R.AAVPSGASTGVYEALELR.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34 - 147   1551.9506    1550.9433    1550.8569  0.0865      0                   K.IPLYQHIANLAGNK.Q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6 - 261   1757.9844    1756.9771    1756.8341  0.1430      0     K.VVIGMDVAASEFYNDK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6 - 338   2499.4695    2498.4622    2498.2686  0.1936      0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K.MTAEIGEQVQIVGDDLLVTNPT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74 - 383   1101.6272    1100.6199    1100.5185  0.1014      0                   R.AGWGVMTSHR.S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74 - 383   1101.6272    1100.6199    1100.5185  0.1014      0                   R.AGWGVMTSHR.S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74 - 383   1117.6031    1116.5958    1116.5134  0.0824      0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AGWGVMTSHR.S Oxidation (M)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18 - 423    806.5246      805.5173      805.4446   0.0727      0                   K.YNQLLR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9 - 446    978.5790      977.5717      977.4970   0.0747      1                   K.FRAPVEPY.-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9 - 446    978.5790      977.5717      977.4970   0.0747      1                   K.FRAPVEPY.-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1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VVADNVHDFVF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743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488.88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1" name="" descr=""/>
          <p:cNvPicPr/>
          <p:nvPr/>
        </p:nvPicPr>
        <p:blipFill>
          <a:blip r:embed="rId1"/>
          <a:stretch/>
        </p:blipFill>
        <p:spPr>
          <a:xfrm>
            <a:off x="45720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1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DYDFGHTLHANHL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74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6308640" y="127080"/>
            <a:ext cx="270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880.19 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4" name="" descr=""/>
          <p:cNvPicPr/>
          <p:nvPr/>
        </p:nvPicPr>
        <p:blipFill>
          <a:blip r:embed="rId1"/>
          <a:stretch/>
        </p:blipFill>
        <p:spPr>
          <a:xfrm>
            <a:off x="380880" y="13716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"/>
          <p:cNvSpPr/>
          <p:nvPr/>
        </p:nvSpPr>
        <p:spPr>
          <a:xfrm>
            <a:off x="684360" y="109440"/>
            <a:ext cx="7164360" cy="13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Arial"/>
              </a:rPr>
              <a:t>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O1536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5/4.94     Mr obsd/calcd:33720/3119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7772400" y="304920"/>
            <a:ext cx="16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7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PlaceHolder 1"/>
          <p:cNvSpPr>
            <a:spLocks noGrp="1"/>
          </p:cNvSpPr>
          <p:nvPr>
            <p:ph type="title"/>
          </p:nvPr>
        </p:nvSpPr>
        <p:spPr>
          <a:xfrm>
            <a:off x="-360" y="46479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br>
              <a:rPr sz="4400"/>
            </a:b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2"/>
          <p:cNvSpPr>
            <a:spLocks noGrp="1"/>
          </p:cNvSpPr>
          <p:nvPr>
            <p:ph/>
          </p:nvPr>
        </p:nvSpPr>
        <p:spPr>
          <a:xfrm>
            <a:off x="609480" y="144792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2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zh-CN" sz="32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nsnlf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yi gaifngvkft dvpinpkvrf dfilafiidy ttetnpptpt ngkfnifwq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tvltpsavas i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qsnpnv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 avsmggatvn drpvffnits vdswvnnave sltgiiqdn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dgididyeq fqvdpdtfte cvgrlitvlk akgvi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asi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pfgnaevq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hymalwakyg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vidyinfqf yaygasttea qyvdffnqqi vnypggnila sfttaattts vpvetalsa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rtlqkegkly gifiwaadhs rsqgfkyete sqallanati sy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1" name="" descr=""/>
          <p:cNvPicPr/>
          <p:nvPr/>
        </p:nvPicPr>
        <p:blipFill>
          <a:blip r:embed="rId1"/>
          <a:stretch/>
        </p:blipFill>
        <p:spPr>
          <a:xfrm>
            <a:off x="457200" y="1981080"/>
            <a:ext cx="8305920" cy="2438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ASIAPFGNAEVQ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o.: AAO1536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506.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4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C375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06/5.01   Mr obsd/calcd:29305/1896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6308640" y="127080"/>
            <a:ext cx="27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M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7" name="" descr=""/>
          <p:cNvPicPr/>
          <p:nvPr/>
        </p:nvPicPr>
        <p:blipFill>
          <a:blip r:embed="rId1"/>
          <a:stretch/>
        </p:blipFill>
        <p:spPr>
          <a:xfrm>
            <a:off x="3049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1905120" y="4114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0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533520" y="2559600"/>
            <a:ext cx="86104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ELAAFFGQTS HETTGG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S SDQFQWGYCF KEEINKATSP PYYGRGPIQ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TGQSNYQAAG NALGLDLVGN PDLVSTDAVV SFKTAIWFWM TAQGNKPSC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VILGRWTPS AADTAAYRVP GYDGITNIIN GGIECGVGQN DANVDRIGY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RYCDMLGTG YGSNLDCYNQ RNFA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/>
          </p:nvPr>
        </p:nvSpPr>
        <p:spPr>
          <a:xfrm>
            <a:off x="-360" y="1447920"/>
            <a:ext cx="937260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– End  Observed  Mr(expt)  Mr(calc)    Delta    Miss       Sequence</a:t>
            </a:r>
            <a:r>
              <a:rPr b="1" lang="zh-CN" sz="4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 - 18     1910.0925    1909.0852  1908.8965   0.1887     0         -.ELAAFFGQTSHETTGGTR.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 - 18     1910.0925    1909.0852  1908.8965   0.1887     0         -.ELAAFFGQTSHETTGGTR.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"/>
          <p:cNvSpPr/>
          <p:nvPr/>
        </p:nvSpPr>
        <p:spPr>
          <a:xfrm>
            <a:off x="684360" y="109440"/>
            <a:ext cx="5640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eptide sequences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LAAFFGQTSHETTGGT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AC375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6308640" y="127080"/>
            <a:ext cx="270828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CID of MH</a:t>
            </a:r>
            <a:r>
              <a:rPr b="0" lang="zh-CN" sz="18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910.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(precursor 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6" name="" descr=""/>
          <p:cNvPicPr/>
          <p:nvPr/>
        </p:nvPicPr>
        <p:blipFill>
          <a:blip r:embed="rId1"/>
          <a:stretch/>
        </p:blipFill>
        <p:spPr>
          <a:xfrm>
            <a:off x="3808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7T06:40:51Z</dcterms:created>
  <dc:creator>微软用户</dc:creator>
  <dc:description/>
  <dc:language>en-US</dc:language>
  <cp:lastModifiedBy>微软用户</cp:lastModifiedBy>
  <dcterms:modified xsi:type="dcterms:W3CDTF">2010-07-18T06:14:02Z</dcterms:modified>
  <cp:revision>18</cp:revision>
  <dc:subject/>
  <dc:title>幻灯片 1</dc:title>
</cp:coreProperties>
</file>